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00" d="100"/>
          <a:sy n="200" d="100"/>
        </p:scale>
        <p:origin x="-256" y="56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44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324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696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734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705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928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96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80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842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25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478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420F6-2687-4B46-82D8-1341462D3700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35714-FD31-4D24-AF2D-CECA0B37F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444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1254" y="1389247"/>
            <a:ext cx="1371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ade II astrocytom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4366" y="3224539"/>
            <a:ext cx="1371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ade III astrocytom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67478" y="5008605"/>
            <a:ext cx="1371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ade IV astrocytoma (GBM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1353185" y="837180"/>
            <a:ext cx="2639425" cy="1576017"/>
            <a:chOff x="1353185" y="837180"/>
            <a:chExt cx="2639425" cy="1576017"/>
          </a:xfrm>
        </p:grpSpPr>
        <p:grpSp>
          <p:nvGrpSpPr>
            <p:cNvPr id="6" name="Group 5"/>
            <p:cNvGrpSpPr/>
            <p:nvPr/>
          </p:nvGrpSpPr>
          <p:grpSpPr>
            <a:xfrm>
              <a:off x="2967137" y="837180"/>
              <a:ext cx="1025473" cy="1562100"/>
              <a:chOff x="3153747" y="1208697"/>
              <a:chExt cx="1025473" cy="1562100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41" t="4185" r="13637" b="4608"/>
              <a:stretch/>
            </p:blipFill>
            <p:spPr bwMode="auto">
              <a:xfrm>
                <a:off x="3153747" y="1208697"/>
                <a:ext cx="222866" cy="15621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3319495" y="1538013"/>
                <a:ext cx="7628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en-US" sz="6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exon (8.4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319480" y="1676124"/>
                <a:ext cx="85973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’ UTR (2.3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319464" y="1818998"/>
                <a:ext cx="8597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’ UTR (13.9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319447" y="1971398"/>
                <a:ext cx="85977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ene body (34.9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319431" y="2104746"/>
                <a:ext cx="8251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SS1500 (22.6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319416" y="2252383"/>
                <a:ext cx="8598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SS200 (17.5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1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80" t="4185" r="28118" b="4608"/>
            <a:stretch/>
          </p:blipFill>
          <p:spPr bwMode="auto">
            <a:xfrm>
              <a:off x="1353185" y="851097"/>
              <a:ext cx="1706724" cy="1562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74" name="Group 73"/>
          <p:cNvGrpSpPr/>
          <p:nvPr/>
        </p:nvGrpSpPr>
        <p:grpSpPr>
          <a:xfrm>
            <a:off x="1388315" y="2671736"/>
            <a:ext cx="2659810" cy="1620279"/>
            <a:chOff x="1257688" y="3637003"/>
            <a:chExt cx="2659810" cy="1620279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33" t="1870" r="30200" b="4607"/>
            <a:stretch/>
          </p:blipFill>
          <p:spPr bwMode="auto">
            <a:xfrm>
              <a:off x="1257688" y="3637003"/>
              <a:ext cx="1628781" cy="16017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4" name="Group 33"/>
            <p:cNvGrpSpPr/>
            <p:nvPr/>
          </p:nvGrpSpPr>
          <p:grpSpPr>
            <a:xfrm>
              <a:off x="2853687" y="3695182"/>
              <a:ext cx="1063811" cy="1562100"/>
              <a:chOff x="3153747" y="1208697"/>
              <a:chExt cx="1063811" cy="1562100"/>
            </a:xfrm>
          </p:grpSpPr>
          <p:pic>
            <p:nvPicPr>
              <p:cNvPr id="35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41" t="4185" r="13637" b="4608"/>
              <a:stretch/>
            </p:blipFill>
            <p:spPr bwMode="auto">
              <a:xfrm>
                <a:off x="3153747" y="1208697"/>
                <a:ext cx="222866" cy="15621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6" name="TextBox 35"/>
              <p:cNvSpPr txBox="1"/>
              <p:nvPr/>
            </p:nvSpPr>
            <p:spPr>
              <a:xfrm>
                <a:off x="3319495" y="1538013"/>
                <a:ext cx="8079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en-US" sz="6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exon (8.9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319479" y="1676124"/>
                <a:ext cx="84256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’ UTR (2.7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319464" y="1818998"/>
                <a:ext cx="89809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’ UTR (13.8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319447" y="1971398"/>
                <a:ext cx="8981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ene body (34.9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3319432" y="2104746"/>
                <a:ext cx="80797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SS1500 (21.7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3319415" y="2252383"/>
                <a:ext cx="80798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SS200 (17.9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75" name="Group 74"/>
          <p:cNvGrpSpPr/>
          <p:nvPr/>
        </p:nvGrpSpPr>
        <p:grpSpPr>
          <a:xfrm>
            <a:off x="1369264" y="4487050"/>
            <a:ext cx="2678861" cy="1647560"/>
            <a:chOff x="1238637" y="6034192"/>
            <a:chExt cx="2678861" cy="164756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35" t="1930" r="28628" b="4978"/>
            <a:stretch/>
          </p:blipFill>
          <p:spPr bwMode="auto">
            <a:xfrm>
              <a:off x="1238637" y="6034192"/>
              <a:ext cx="1690645" cy="15943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2" name="Group 41"/>
            <p:cNvGrpSpPr/>
            <p:nvPr/>
          </p:nvGrpSpPr>
          <p:grpSpPr>
            <a:xfrm>
              <a:off x="2876944" y="6119652"/>
              <a:ext cx="1040554" cy="1562100"/>
              <a:chOff x="3153747" y="1208697"/>
              <a:chExt cx="1040554" cy="1562100"/>
            </a:xfrm>
          </p:grpSpPr>
          <p:pic>
            <p:nvPicPr>
              <p:cNvPr id="43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41" t="4185" r="13637" b="4608"/>
              <a:stretch/>
            </p:blipFill>
            <p:spPr bwMode="auto">
              <a:xfrm>
                <a:off x="3153747" y="1208697"/>
                <a:ext cx="222866" cy="15621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4" name="TextBox 43"/>
              <p:cNvSpPr txBox="1"/>
              <p:nvPr/>
            </p:nvSpPr>
            <p:spPr>
              <a:xfrm>
                <a:off x="3319496" y="1538013"/>
                <a:ext cx="81928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en-US" sz="6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exon (9.8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319480" y="1676124"/>
                <a:ext cx="81930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’ UTR (2.8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319464" y="1818998"/>
                <a:ext cx="72243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’ UTR (13.5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3319447" y="1971398"/>
                <a:ext cx="8748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ene body (36.1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319431" y="2104746"/>
                <a:ext cx="87487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SS1500 (21.1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319416" y="2252383"/>
                <a:ext cx="81937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SS200 (17.6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2" name="Group 31"/>
          <p:cNvGrpSpPr/>
          <p:nvPr/>
        </p:nvGrpSpPr>
        <p:grpSpPr>
          <a:xfrm>
            <a:off x="4143372" y="4487051"/>
            <a:ext cx="2662241" cy="1647559"/>
            <a:chOff x="4143372" y="6034193"/>
            <a:chExt cx="2662241" cy="1647559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32" t="2285" r="30594" b="4623"/>
            <a:stretch/>
          </p:blipFill>
          <p:spPr bwMode="auto">
            <a:xfrm>
              <a:off x="4143372" y="6034193"/>
              <a:ext cx="1714503" cy="15943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0" name="Group 49"/>
            <p:cNvGrpSpPr/>
            <p:nvPr/>
          </p:nvGrpSpPr>
          <p:grpSpPr>
            <a:xfrm>
              <a:off x="5810644" y="6119652"/>
              <a:ext cx="994969" cy="1562100"/>
              <a:chOff x="3153747" y="1208697"/>
              <a:chExt cx="994969" cy="1562100"/>
            </a:xfrm>
          </p:grpSpPr>
          <p:pic>
            <p:nvPicPr>
              <p:cNvPr id="51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41" t="4185" r="13637" b="4608"/>
              <a:stretch/>
            </p:blipFill>
            <p:spPr bwMode="auto">
              <a:xfrm>
                <a:off x="3153747" y="1208697"/>
                <a:ext cx="222866" cy="15621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2" name="TextBox 51"/>
              <p:cNvSpPr txBox="1"/>
              <p:nvPr/>
            </p:nvSpPr>
            <p:spPr>
              <a:xfrm>
                <a:off x="3319496" y="1538013"/>
                <a:ext cx="72920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land (73.8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3319479" y="1676124"/>
                <a:ext cx="79113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 shelf (0.5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319464" y="1818998"/>
                <a:ext cx="82925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 shore (11.8%)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319448" y="1971398"/>
                <a:ext cx="79116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 shelf (0.5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3319432" y="2104746"/>
                <a:ext cx="72927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 shore (7.9%)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3319415" y="2252383"/>
                <a:ext cx="82930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pen sea (5.5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1" name="Group 10"/>
          <p:cNvGrpSpPr/>
          <p:nvPr/>
        </p:nvGrpSpPr>
        <p:grpSpPr>
          <a:xfrm>
            <a:off x="4143374" y="2671736"/>
            <a:ext cx="2662239" cy="1634924"/>
            <a:chOff x="4143374" y="3637003"/>
            <a:chExt cx="2662239" cy="1634924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49" t="2088" r="29776" b="4387"/>
            <a:stretch/>
          </p:blipFill>
          <p:spPr bwMode="auto">
            <a:xfrm>
              <a:off x="4143374" y="3637003"/>
              <a:ext cx="1714501" cy="16017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8" name="Group 57"/>
            <p:cNvGrpSpPr/>
            <p:nvPr/>
          </p:nvGrpSpPr>
          <p:grpSpPr>
            <a:xfrm>
              <a:off x="5782069" y="3709827"/>
              <a:ext cx="1023544" cy="1562100"/>
              <a:chOff x="3153747" y="1208697"/>
              <a:chExt cx="1023544" cy="1562100"/>
            </a:xfrm>
          </p:grpSpPr>
          <p:pic>
            <p:nvPicPr>
              <p:cNvPr id="59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41" t="4185" r="13637" b="4608"/>
              <a:stretch/>
            </p:blipFill>
            <p:spPr bwMode="auto">
              <a:xfrm>
                <a:off x="3153747" y="1208697"/>
                <a:ext cx="222866" cy="15621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0" name="TextBox 59"/>
              <p:cNvSpPr txBox="1"/>
              <p:nvPr/>
            </p:nvSpPr>
            <p:spPr>
              <a:xfrm>
                <a:off x="3319495" y="1538013"/>
                <a:ext cx="7577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land (72.7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3319479" y="1676124"/>
                <a:ext cx="75779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 shelf (0.5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3319463" y="1818998"/>
                <a:ext cx="7578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 shore (11.5%)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3300396" y="1971398"/>
                <a:ext cx="7768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 shelf (0.4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3319431" y="2104746"/>
                <a:ext cx="81975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 shore (9.1%)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3319415" y="2252383"/>
                <a:ext cx="85787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pen sea (7.1%)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" name="Group 9"/>
          <p:cNvGrpSpPr/>
          <p:nvPr/>
        </p:nvGrpSpPr>
        <p:grpSpPr>
          <a:xfrm>
            <a:off x="4144931" y="793051"/>
            <a:ext cx="2622582" cy="1638689"/>
            <a:chOff x="4144931" y="793051"/>
            <a:chExt cx="2622582" cy="1638689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41" t="1744" r="30540" b="2576"/>
            <a:stretch/>
          </p:blipFill>
          <p:spPr bwMode="auto">
            <a:xfrm>
              <a:off x="4144931" y="793051"/>
              <a:ext cx="1712944" cy="16386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66" name="Group 65"/>
            <p:cNvGrpSpPr/>
            <p:nvPr/>
          </p:nvGrpSpPr>
          <p:grpSpPr>
            <a:xfrm>
              <a:off x="5810644" y="842760"/>
              <a:ext cx="956869" cy="1562100"/>
              <a:chOff x="3153747" y="1208697"/>
              <a:chExt cx="956869" cy="1562100"/>
            </a:xfrm>
          </p:grpSpPr>
          <p:pic>
            <p:nvPicPr>
              <p:cNvPr id="67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41" t="4185" r="13637" b="4608"/>
              <a:stretch/>
            </p:blipFill>
            <p:spPr bwMode="auto">
              <a:xfrm>
                <a:off x="3153747" y="1208697"/>
                <a:ext cx="222866" cy="15621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8" name="TextBox 67"/>
              <p:cNvSpPr txBox="1"/>
              <p:nvPr/>
            </p:nvSpPr>
            <p:spPr>
              <a:xfrm>
                <a:off x="3319496" y="1538013"/>
                <a:ext cx="72920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land (67.9%)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3319480" y="1676124"/>
                <a:ext cx="7292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 shelf (0.6%)  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3319464" y="1818998"/>
                <a:ext cx="79115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 shore (13.5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3319448" y="1971398"/>
                <a:ext cx="79116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 shelf (0.5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3319432" y="2104746"/>
                <a:ext cx="79118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 shore (10.4%)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3319415" y="2252383"/>
                <a:ext cx="79120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pen sea (7.1%) 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6" name="TextBox 75"/>
          <p:cNvSpPr txBox="1"/>
          <p:nvPr/>
        </p:nvSpPr>
        <p:spPr>
          <a:xfrm>
            <a:off x="1151906" y="176437"/>
            <a:ext cx="226665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i with respect to gene feature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942608" y="160888"/>
            <a:ext cx="229096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i with respect to genomic location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8" name="Group 77"/>
          <p:cNvGrpSpPr/>
          <p:nvPr/>
        </p:nvGrpSpPr>
        <p:grpSpPr>
          <a:xfrm>
            <a:off x="5810628" y="7477352"/>
            <a:ext cx="1047372" cy="1562100"/>
            <a:chOff x="3153747" y="1208697"/>
            <a:chExt cx="1047372" cy="1562100"/>
          </a:xfrm>
        </p:grpSpPr>
        <p:pic>
          <p:nvPicPr>
            <p:cNvPr id="79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541" t="4185" r="13637" b="4608"/>
            <a:stretch/>
          </p:blipFill>
          <p:spPr bwMode="auto">
            <a:xfrm>
              <a:off x="3153747" y="1208697"/>
              <a:ext cx="222866" cy="1562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0" name="TextBox 79"/>
            <p:cNvSpPr txBox="1"/>
            <p:nvPr/>
          </p:nvSpPr>
          <p:spPr>
            <a:xfrm>
              <a:off x="3319495" y="1538013"/>
              <a:ext cx="72922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sland (35.6%)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319480" y="1676124"/>
              <a:ext cx="67208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 shelf (4.1%) 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319464" y="1818998"/>
              <a:ext cx="79116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 shore (14%)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319448" y="1971398"/>
              <a:ext cx="72927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 shelf (3.6%)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319432" y="2104746"/>
              <a:ext cx="79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 shore (11.2%)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319415" y="2252383"/>
              <a:ext cx="8817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pen sea (31.4%)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3005225" y="7514639"/>
            <a:ext cx="1103558" cy="1562100"/>
            <a:chOff x="3153747" y="1208697"/>
            <a:chExt cx="1005920" cy="1562100"/>
          </a:xfrm>
        </p:grpSpPr>
        <p:pic>
          <p:nvPicPr>
            <p:cNvPr id="8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541" t="4185" r="13637" b="4608"/>
            <a:stretch/>
          </p:blipFill>
          <p:spPr bwMode="auto">
            <a:xfrm>
              <a:off x="3153747" y="1208697"/>
              <a:ext cx="222866" cy="1562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9" name="TextBox 88"/>
            <p:cNvSpPr txBox="1"/>
            <p:nvPr/>
          </p:nvSpPr>
          <p:spPr>
            <a:xfrm>
              <a:off x="3319496" y="1538013"/>
              <a:ext cx="73427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6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exon (6.3%)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3319480" y="1676124"/>
              <a:ext cx="7342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’ UTR (4.6%)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319464" y="1818998"/>
              <a:ext cx="7027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 UTR (11.7%) 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319447" y="1971398"/>
              <a:ext cx="8402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ene body (44.1%)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3319432" y="2104746"/>
              <a:ext cx="734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SS1500 (19%)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319415" y="2252383"/>
              <a:ext cx="73435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SS200 (14.4%)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5" name="TextBox 94"/>
          <p:cNvSpPr txBox="1"/>
          <p:nvPr/>
        </p:nvSpPr>
        <p:spPr>
          <a:xfrm>
            <a:off x="262699" y="7994739"/>
            <a:ext cx="1371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ray desig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098320" y="6723630"/>
            <a:ext cx="228002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analyzed 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i with respect to gene features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3816070" y="6714089"/>
            <a:ext cx="248874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analyzed  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oci with respect to genomic location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43" t="3798" r="29640" b="3049"/>
          <a:stretch/>
        </p:blipFill>
        <p:spPr bwMode="auto">
          <a:xfrm>
            <a:off x="1381760" y="7353190"/>
            <a:ext cx="1698376" cy="1676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55" t="2230" r="27615" b="1442"/>
          <a:stretch/>
        </p:blipFill>
        <p:spPr bwMode="auto">
          <a:xfrm>
            <a:off x="4048125" y="7299682"/>
            <a:ext cx="1880593" cy="17656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712943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9</TotalTime>
  <Words>340</Words>
  <Application>Microsoft Macintosh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ctoria Hill</dc:creator>
  <cp:lastModifiedBy>Farida Latif</cp:lastModifiedBy>
  <cp:revision>14</cp:revision>
  <cp:lastPrinted>2014-06-09T09:31:35Z</cp:lastPrinted>
  <dcterms:created xsi:type="dcterms:W3CDTF">2013-07-12T05:08:36Z</dcterms:created>
  <dcterms:modified xsi:type="dcterms:W3CDTF">2014-07-10T12:28:03Z</dcterms:modified>
</cp:coreProperties>
</file>